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F1BD68-1144-49B5-8B96-5FE858DAA63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26571F-C841-47EE-9B4D-E4AD0011D1E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74EF1F-16BA-4CCD-8307-D2896100F89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A37F56-F81B-4362-9CDC-C6127DB59EB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B1DC42-A3B1-4675-A076-39586112407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D3AD9B-CD0D-415F-85D1-EA02BDBE74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70E6B7-CA7D-4204-AA7D-274068C9E4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11DF7A-163A-4EBE-889B-D91AFA64FED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B3A097-81CA-484A-A558-D95ADA3A7A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35BBB6-3FDD-41A4-B925-331A7BDF73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3C5935-6462-4D0C-A1CC-678774778D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CCAD8E-2B6A-47CE-9153-C3779F5378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71D52E-B12F-4AE1-9AEB-6B41CF166524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5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3"/>
          <p:cNvSpPr/>
          <p:nvPr/>
        </p:nvSpPr>
        <p:spPr>
          <a:xfrm>
            <a:off x="5013360" y="8308800"/>
            <a:ext cx="154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Fig. S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图片 3" descr="ikkb.jpg"/>
          <p:cNvPicPr/>
          <p:nvPr/>
        </p:nvPicPr>
        <p:blipFill>
          <a:blip r:embed="rId1"/>
          <a:stretch/>
        </p:blipFill>
        <p:spPr>
          <a:xfrm>
            <a:off x="3252960" y="5508720"/>
            <a:ext cx="1199880" cy="287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3" name="图片 4" descr="ikkb.jpg"/>
          <p:cNvPicPr/>
          <p:nvPr/>
        </p:nvPicPr>
        <p:blipFill>
          <a:blip r:embed="rId2"/>
          <a:stretch/>
        </p:blipFill>
        <p:spPr>
          <a:xfrm>
            <a:off x="2004840" y="5508720"/>
            <a:ext cx="1200240" cy="287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4" name="图片 5" descr="4_副本ikkb.jpg"/>
          <p:cNvPicPr/>
          <p:nvPr/>
        </p:nvPicPr>
        <p:blipFill>
          <a:blip r:embed="rId3">
            <a:lum contrast="30000"/>
          </a:blip>
          <a:stretch/>
        </p:blipFill>
        <p:spPr>
          <a:xfrm>
            <a:off x="2004840" y="4586400"/>
            <a:ext cx="2448000" cy="330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5" name="TextBox 6"/>
          <p:cNvSpPr/>
          <p:nvPr/>
        </p:nvSpPr>
        <p:spPr>
          <a:xfrm>
            <a:off x="4378320" y="4624560"/>
            <a:ext cx="86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-IKK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7"/>
          <p:cNvSpPr/>
          <p:nvPr/>
        </p:nvSpPr>
        <p:spPr>
          <a:xfrm>
            <a:off x="4467240" y="5040360"/>
            <a:ext cx="86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IB: Fl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直接连接符 9"/>
          <p:cNvSpPr/>
          <p:nvPr/>
        </p:nvSpPr>
        <p:spPr>
          <a:xfrm>
            <a:off x="4498920" y="5029200"/>
            <a:ext cx="0" cy="287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0"/>
          <p:cNvSpPr/>
          <p:nvPr/>
        </p:nvSpPr>
        <p:spPr>
          <a:xfrm>
            <a:off x="4370400" y="5468760"/>
            <a:ext cx="1579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-IKK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 (Inpu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直接连接符 24"/>
          <p:cNvSpPr/>
          <p:nvPr/>
        </p:nvSpPr>
        <p:spPr>
          <a:xfrm>
            <a:off x="2092320" y="3821040"/>
            <a:ext cx="10429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直接连接符 25"/>
          <p:cNvSpPr/>
          <p:nvPr/>
        </p:nvSpPr>
        <p:spPr>
          <a:xfrm>
            <a:off x="3243240" y="3821040"/>
            <a:ext cx="1152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26"/>
          <p:cNvSpPr/>
          <p:nvPr/>
        </p:nvSpPr>
        <p:spPr>
          <a:xfrm>
            <a:off x="2363760" y="3602160"/>
            <a:ext cx="72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Ig 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27"/>
          <p:cNvSpPr/>
          <p:nvPr/>
        </p:nvSpPr>
        <p:spPr>
          <a:xfrm>
            <a:off x="3481560" y="3602160"/>
            <a:ext cx="934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- Fl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28"/>
          <p:cNvSpPr/>
          <p:nvPr/>
        </p:nvSpPr>
        <p:spPr>
          <a:xfrm>
            <a:off x="1695600" y="361152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IP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：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图片 30" descr="ikkb ip.jpg"/>
          <p:cNvPicPr/>
          <p:nvPr/>
        </p:nvPicPr>
        <p:blipFill>
          <a:blip r:embed="rId4">
            <a:lum bright="-12000"/>
          </a:blip>
          <a:srcRect l="0" t="17419" r="0" b="12903"/>
          <a:stretch/>
        </p:blipFill>
        <p:spPr>
          <a:xfrm>
            <a:off x="2982960" y="1519200"/>
            <a:ext cx="1008000" cy="287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5" name="图片 31" descr="flag ip.jpg"/>
          <p:cNvPicPr/>
          <p:nvPr/>
        </p:nvPicPr>
        <p:blipFill>
          <a:blip r:embed="rId5">
            <a:lum bright="-28000"/>
          </a:blip>
          <a:stretch/>
        </p:blipFill>
        <p:spPr>
          <a:xfrm>
            <a:off x="2982960" y="1841400"/>
            <a:ext cx="1008000" cy="282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6" name="TextBox 32"/>
          <p:cNvSpPr/>
          <p:nvPr/>
        </p:nvSpPr>
        <p:spPr>
          <a:xfrm>
            <a:off x="2200320" y="1106640"/>
            <a:ext cx="1224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Flag-SRC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3"/>
          <p:cNvSpPr/>
          <p:nvPr/>
        </p:nvSpPr>
        <p:spPr>
          <a:xfrm>
            <a:off x="2592360" y="126216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IKK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4"/>
          <p:cNvSpPr/>
          <p:nvPr/>
        </p:nvSpPr>
        <p:spPr>
          <a:xfrm>
            <a:off x="3054240" y="1111320"/>
            <a:ext cx="1152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+       +     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+       +     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35"/>
          <p:cNvSpPr/>
          <p:nvPr/>
        </p:nvSpPr>
        <p:spPr>
          <a:xfrm>
            <a:off x="2911320" y="833400"/>
            <a:ext cx="1305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Input  IgG  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-Fla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直接连接符 37"/>
          <p:cNvSpPr/>
          <p:nvPr/>
        </p:nvSpPr>
        <p:spPr>
          <a:xfrm>
            <a:off x="3429000" y="826920"/>
            <a:ext cx="612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38"/>
          <p:cNvSpPr/>
          <p:nvPr/>
        </p:nvSpPr>
        <p:spPr>
          <a:xfrm>
            <a:off x="3568680" y="611280"/>
            <a:ext cx="647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39"/>
          <p:cNvSpPr/>
          <p:nvPr/>
        </p:nvSpPr>
        <p:spPr>
          <a:xfrm>
            <a:off x="3919680" y="1496880"/>
            <a:ext cx="86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-IKK</a:t>
            </a:r>
            <a:r>
              <a:rPr b="1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41"/>
          <p:cNvSpPr/>
          <p:nvPr/>
        </p:nvSpPr>
        <p:spPr>
          <a:xfrm>
            <a:off x="3919680" y="1827360"/>
            <a:ext cx="1015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 Unicode MS"/>
              </a:rPr>
              <a:t>-Flag-SRC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45"/>
          <p:cNvSpPr/>
          <p:nvPr/>
        </p:nvSpPr>
        <p:spPr>
          <a:xfrm>
            <a:off x="1407960" y="530280"/>
            <a:ext cx="43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48"/>
          <p:cNvSpPr/>
          <p:nvPr/>
        </p:nvSpPr>
        <p:spPr>
          <a:xfrm>
            <a:off x="1413000" y="2620800"/>
            <a:ext cx="50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图片 1" descr="SRC-3.jpg"/>
          <p:cNvPicPr/>
          <p:nvPr/>
        </p:nvPicPr>
        <p:blipFill>
          <a:blip r:embed="rId6"/>
          <a:srcRect l="0" t="18781" r="0" b="37313"/>
          <a:stretch/>
        </p:blipFill>
        <p:spPr>
          <a:xfrm>
            <a:off x="2001960" y="4946760"/>
            <a:ext cx="2447640" cy="504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67" name="Group 81"/>
          <p:cNvGrpSpPr/>
          <p:nvPr/>
        </p:nvGrpSpPr>
        <p:grpSpPr>
          <a:xfrm>
            <a:off x="1854360" y="3090960"/>
            <a:ext cx="2871360" cy="110520"/>
            <a:chOff x="1854360" y="3090960"/>
            <a:chExt cx="2871360" cy="110520"/>
          </a:xfrm>
        </p:grpSpPr>
        <p:sp>
          <p:nvSpPr>
            <p:cNvPr id="68" name="Freeform 82"/>
            <p:cNvSpPr/>
            <p:nvPr/>
          </p:nvSpPr>
          <p:spPr>
            <a:xfrm>
              <a:off x="1854360" y="3090960"/>
              <a:ext cx="2871360" cy="110520"/>
            </a:xfrm>
            <a:custGeom>
              <a:avLst/>
              <a:gdLst>
                <a:gd name="textAreaLeft" fmla="*/ 0 w 2871360"/>
                <a:gd name="textAreaRight" fmla="*/ 2871720 w 2871360"/>
                <a:gd name="textAreaTop" fmla="*/ 0 h 110520"/>
                <a:gd name="textAreaBottom" fmla="*/ 110880 h 110520"/>
              </a:gdLst>
              <a:ahLst/>
              <a:rect l="textAreaLeft" t="textAreaTop" r="textAreaRight" b="textAreaBottom"/>
              <a:pathLst>
                <a:path w="17200" h="750">
                  <a:moveTo>
                    <a:pt x="125" y="0"/>
                  </a:moveTo>
                  <a:cubicBezTo>
                    <a:pt x="56" y="0"/>
                    <a:pt x="0" y="56"/>
                    <a:pt x="0" y="125"/>
                  </a:cubicBezTo>
                  <a:lnTo>
                    <a:pt x="0" y="625"/>
                  </a:lnTo>
                  <a:cubicBezTo>
                    <a:pt x="0" y="694"/>
                    <a:pt x="56" y="750"/>
                    <a:pt x="125" y="750"/>
                  </a:cubicBezTo>
                  <a:lnTo>
                    <a:pt x="17075" y="750"/>
                  </a:lnTo>
                  <a:cubicBezTo>
                    <a:pt x="17144" y="750"/>
                    <a:pt x="17200" y="694"/>
                    <a:pt x="17200" y="625"/>
                  </a:cubicBezTo>
                  <a:lnTo>
                    <a:pt x="17200" y="125"/>
                  </a:lnTo>
                  <a:cubicBezTo>
                    <a:pt x="17200" y="56"/>
                    <a:pt x="17144" y="0"/>
                    <a:pt x="17075" y="0"/>
                  </a:cubicBezTo>
                  <a:lnTo>
                    <a:pt x="125" y="0"/>
                  </a:lnTo>
                  <a:close/>
                </a:path>
              </a:pathLst>
            </a:custGeom>
            <a:solidFill>
              <a:srgbClr val="c0c0c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83"/>
            <p:cNvSpPr/>
            <p:nvPr/>
          </p:nvSpPr>
          <p:spPr>
            <a:xfrm>
              <a:off x="1854360" y="3090960"/>
              <a:ext cx="2871360" cy="110520"/>
            </a:xfrm>
            <a:custGeom>
              <a:avLst/>
              <a:gdLst>
                <a:gd name="textAreaLeft" fmla="*/ 0 w 2871360"/>
                <a:gd name="textAreaRight" fmla="*/ 2871720 w 2871360"/>
                <a:gd name="textAreaTop" fmla="*/ 0 h 110520"/>
                <a:gd name="textAreaBottom" fmla="*/ 110880 h 110520"/>
              </a:gdLst>
              <a:ahLst/>
              <a:rect l="textAreaLeft" t="textAreaTop" r="textAreaRight" b="textAreaBottom"/>
              <a:pathLst>
                <a:path w="17200" h="750">
                  <a:moveTo>
                    <a:pt x="125" y="0"/>
                  </a:moveTo>
                  <a:cubicBezTo>
                    <a:pt x="56" y="0"/>
                    <a:pt x="0" y="56"/>
                    <a:pt x="0" y="125"/>
                  </a:cubicBezTo>
                  <a:lnTo>
                    <a:pt x="0" y="625"/>
                  </a:lnTo>
                  <a:cubicBezTo>
                    <a:pt x="0" y="694"/>
                    <a:pt x="56" y="750"/>
                    <a:pt x="125" y="750"/>
                  </a:cubicBezTo>
                  <a:lnTo>
                    <a:pt x="17075" y="750"/>
                  </a:lnTo>
                  <a:cubicBezTo>
                    <a:pt x="17144" y="750"/>
                    <a:pt x="17200" y="694"/>
                    <a:pt x="17200" y="625"/>
                  </a:cubicBezTo>
                  <a:lnTo>
                    <a:pt x="17200" y="125"/>
                  </a:lnTo>
                  <a:cubicBezTo>
                    <a:pt x="17200" y="56"/>
                    <a:pt x="17144" y="0"/>
                    <a:pt x="17075" y="0"/>
                  </a:cubicBezTo>
                  <a:lnTo>
                    <a:pt x="125" y="0"/>
                  </a:lnTo>
                  <a:close/>
                </a:path>
              </a:pathLst>
            </a:custGeom>
            <a:noFill/>
            <a:ln cap="rnd" w="32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0" name="Rectangle 84"/>
          <p:cNvSpPr/>
          <p:nvPr/>
        </p:nvSpPr>
        <p:spPr>
          <a:xfrm>
            <a:off x="2522520" y="3094200"/>
            <a:ext cx="238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/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89"/>
          <p:cNvSpPr/>
          <p:nvPr/>
        </p:nvSpPr>
        <p:spPr>
          <a:xfrm>
            <a:off x="1826640" y="2952720"/>
            <a:ext cx="648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90"/>
          <p:cNvSpPr/>
          <p:nvPr/>
        </p:nvSpPr>
        <p:spPr>
          <a:xfrm>
            <a:off x="2873880" y="294624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58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91"/>
          <p:cNvSpPr/>
          <p:nvPr/>
        </p:nvSpPr>
        <p:spPr>
          <a:xfrm>
            <a:off x="3502440" y="295740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84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92"/>
          <p:cNvSpPr/>
          <p:nvPr/>
        </p:nvSpPr>
        <p:spPr>
          <a:xfrm>
            <a:off x="3932640" y="2948040"/>
            <a:ext cx="256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08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93"/>
          <p:cNvSpPr/>
          <p:nvPr/>
        </p:nvSpPr>
        <p:spPr>
          <a:xfrm>
            <a:off x="4686480" y="2960640"/>
            <a:ext cx="25668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141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94"/>
          <p:cNvSpPr/>
          <p:nvPr/>
        </p:nvSpPr>
        <p:spPr>
          <a:xfrm>
            <a:off x="1779480" y="3173400"/>
            <a:ext cx="69840" cy="144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95"/>
          <p:cNvSpPr/>
          <p:nvPr/>
        </p:nvSpPr>
        <p:spPr>
          <a:xfrm>
            <a:off x="4722840" y="3173400"/>
            <a:ext cx="69840" cy="1440"/>
          </a:xfrm>
          <a:prstGeom prst="line">
            <a:avLst/>
          </a:prstGeom>
          <a:ln w="144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96"/>
          <p:cNvSpPr/>
          <p:nvPr/>
        </p:nvSpPr>
        <p:spPr>
          <a:xfrm>
            <a:off x="1695240" y="3094200"/>
            <a:ext cx="83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97"/>
          <p:cNvSpPr/>
          <p:nvPr/>
        </p:nvSpPr>
        <p:spPr>
          <a:xfrm>
            <a:off x="4800240" y="3110040"/>
            <a:ext cx="8316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0" name="Group 98"/>
          <p:cNvGrpSpPr/>
          <p:nvPr/>
        </p:nvGrpSpPr>
        <p:grpSpPr>
          <a:xfrm>
            <a:off x="1854360" y="3090960"/>
            <a:ext cx="2871360" cy="174240"/>
            <a:chOff x="1854360" y="3090960"/>
            <a:chExt cx="2871360" cy="174240"/>
          </a:xfrm>
        </p:grpSpPr>
        <p:sp>
          <p:nvSpPr>
            <p:cNvPr id="81" name="Freeform 99"/>
            <p:cNvSpPr/>
            <p:nvPr/>
          </p:nvSpPr>
          <p:spPr>
            <a:xfrm>
              <a:off x="1854360" y="3090960"/>
              <a:ext cx="2871360" cy="174240"/>
            </a:xfrm>
            <a:custGeom>
              <a:avLst/>
              <a:gdLst>
                <a:gd name="textAreaLeft" fmla="*/ 0 w 2871360"/>
                <a:gd name="textAreaRight" fmla="*/ 2871720 w 2871360"/>
                <a:gd name="textAreaTop" fmla="*/ 0 h 174240"/>
                <a:gd name="textAreaBottom" fmla="*/ 174240 h 174240"/>
              </a:gdLst>
              <a:ahLst/>
              <a:rect l="textAreaLeft" t="textAreaTop" r="textAreaRight" b="textAreaBottom"/>
              <a:pathLst>
                <a:path w="17200" h="750">
                  <a:moveTo>
                    <a:pt x="125" y="0"/>
                  </a:moveTo>
                  <a:cubicBezTo>
                    <a:pt x="56" y="0"/>
                    <a:pt x="0" y="56"/>
                    <a:pt x="0" y="125"/>
                  </a:cubicBezTo>
                  <a:lnTo>
                    <a:pt x="0" y="625"/>
                  </a:lnTo>
                  <a:cubicBezTo>
                    <a:pt x="0" y="694"/>
                    <a:pt x="56" y="750"/>
                    <a:pt x="125" y="750"/>
                  </a:cubicBezTo>
                  <a:lnTo>
                    <a:pt x="17075" y="750"/>
                  </a:lnTo>
                  <a:cubicBezTo>
                    <a:pt x="17144" y="750"/>
                    <a:pt x="17200" y="694"/>
                    <a:pt x="17200" y="625"/>
                  </a:cubicBezTo>
                  <a:lnTo>
                    <a:pt x="17200" y="125"/>
                  </a:lnTo>
                  <a:cubicBezTo>
                    <a:pt x="17200" y="56"/>
                    <a:pt x="17144" y="0"/>
                    <a:pt x="17075" y="0"/>
                  </a:cubicBezTo>
                  <a:lnTo>
                    <a:pt x="125" y="0"/>
                  </a:lnTo>
                  <a:close/>
                </a:path>
              </a:pathLst>
            </a:custGeom>
            <a:solidFill>
              <a:srgbClr val="ffffff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100"/>
            <p:cNvSpPr/>
            <p:nvPr/>
          </p:nvSpPr>
          <p:spPr>
            <a:xfrm>
              <a:off x="1854360" y="3090960"/>
              <a:ext cx="2871360" cy="174240"/>
            </a:xfrm>
            <a:custGeom>
              <a:avLst/>
              <a:gdLst>
                <a:gd name="textAreaLeft" fmla="*/ 0 w 2871360"/>
                <a:gd name="textAreaRight" fmla="*/ 2871720 w 2871360"/>
                <a:gd name="textAreaTop" fmla="*/ 0 h 174240"/>
                <a:gd name="textAreaBottom" fmla="*/ 174240 h 174240"/>
              </a:gdLst>
              <a:ahLst/>
              <a:rect l="textAreaLeft" t="textAreaTop" r="textAreaRight" b="textAreaBottom"/>
              <a:pathLst>
                <a:path w="17200" h="750">
                  <a:moveTo>
                    <a:pt x="125" y="0"/>
                  </a:moveTo>
                  <a:cubicBezTo>
                    <a:pt x="56" y="0"/>
                    <a:pt x="0" y="56"/>
                    <a:pt x="0" y="125"/>
                  </a:cubicBezTo>
                  <a:lnTo>
                    <a:pt x="0" y="625"/>
                  </a:lnTo>
                  <a:cubicBezTo>
                    <a:pt x="0" y="694"/>
                    <a:pt x="56" y="750"/>
                    <a:pt x="125" y="750"/>
                  </a:cubicBezTo>
                  <a:lnTo>
                    <a:pt x="17075" y="750"/>
                  </a:lnTo>
                  <a:cubicBezTo>
                    <a:pt x="17144" y="750"/>
                    <a:pt x="17200" y="694"/>
                    <a:pt x="17200" y="625"/>
                  </a:cubicBezTo>
                  <a:lnTo>
                    <a:pt x="17200" y="125"/>
                  </a:lnTo>
                  <a:cubicBezTo>
                    <a:pt x="17200" y="56"/>
                    <a:pt x="17144" y="0"/>
                    <a:pt x="17075" y="0"/>
                  </a:cubicBezTo>
                  <a:lnTo>
                    <a:pt x="125" y="0"/>
                  </a:lnTo>
                  <a:close/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Rectangle 101"/>
          <p:cNvSpPr/>
          <p:nvPr/>
        </p:nvSpPr>
        <p:spPr>
          <a:xfrm>
            <a:off x="1979640" y="3089160"/>
            <a:ext cx="43488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HL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Rectangle 102"/>
          <p:cNvSpPr/>
          <p:nvPr/>
        </p:nvSpPr>
        <p:spPr>
          <a:xfrm>
            <a:off x="2587680" y="3089160"/>
            <a:ext cx="2383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/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Rectangle 103"/>
          <p:cNvSpPr/>
          <p:nvPr/>
        </p:nvSpPr>
        <p:spPr>
          <a:xfrm>
            <a:off x="3620880" y="3089160"/>
            <a:ext cx="262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I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104"/>
          <p:cNvSpPr/>
          <p:nvPr/>
        </p:nvSpPr>
        <p:spPr>
          <a:xfrm>
            <a:off x="4251240" y="3089160"/>
            <a:ext cx="3132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105"/>
          <p:cNvSpPr/>
          <p:nvPr/>
        </p:nvSpPr>
        <p:spPr>
          <a:xfrm>
            <a:off x="2448360" y="2946240"/>
            <a:ext cx="192600" cy="13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32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106"/>
          <p:cNvSpPr/>
          <p:nvPr/>
        </p:nvSpPr>
        <p:spPr>
          <a:xfrm>
            <a:off x="3087360" y="3089160"/>
            <a:ext cx="262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I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107"/>
          <p:cNvSpPr/>
          <p:nvPr/>
        </p:nvSpPr>
        <p:spPr>
          <a:xfrm>
            <a:off x="2993400" y="2671920"/>
            <a:ext cx="560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RC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43"/>
          <p:cNvSpPr/>
          <p:nvPr/>
        </p:nvSpPr>
        <p:spPr>
          <a:xfrm rot="10800000">
            <a:off x="3173040" y="3506760"/>
            <a:ext cx="332640" cy="10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b/HL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44"/>
          <p:cNvSpPr/>
          <p:nvPr/>
        </p:nvSpPr>
        <p:spPr>
          <a:xfrm rot="10800000">
            <a:off x="3387240" y="3506760"/>
            <a:ext cx="332640" cy="10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S/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45"/>
          <p:cNvSpPr/>
          <p:nvPr/>
        </p:nvSpPr>
        <p:spPr>
          <a:xfrm rot="10800000">
            <a:off x="3621240" y="3492360"/>
            <a:ext cx="332640" cy="10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RI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46"/>
          <p:cNvSpPr/>
          <p:nvPr/>
        </p:nvSpPr>
        <p:spPr>
          <a:xfrm rot="10800000">
            <a:off x="3850920" y="3506760"/>
            <a:ext cx="332640" cy="10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CI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47"/>
          <p:cNvSpPr/>
          <p:nvPr/>
        </p:nvSpPr>
        <p:spPr>
          <a:xfrm rot="10800000">
            <a:off x="4061880" y="3506760"/>
            <a:ext cx="332640" cy="10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H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48"/>
          <p:cNvSpPr/>
          <p:nvPr/>
        </p:nvSpPr>
        <p:spPr>
          <a:xfrm rot="10800000">
            <a:off x="1982520" y="3510000"/>
            <a:ext cx="332640" cy="10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bHL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49"/>
          <p:cNvSpPr/>
          <p:nvPr/>
        </p:nvSpPr>
        <p:spPr>
          <a:xfrm rot="10800000">
            <a:off x="2217240" y="3492360"/>
            <a:ext cx="332640" cy="10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S/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50"/>
          <p:cNvSpPr/>
          <p:nvPr/>
        </p:nvSpPr>
        <p:spPr>
          <a:xfrm rot="10800000">
            <a:off x="2463480" y="3492360"/>
            <a:ext cx="332640" cy="10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RI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51"/>
          <p:cNvSpPr/>
          <p:nvPr/>
        </p:nvSpPr>
        <p:spPr>
          <a:xfrm rot="10800000">
            <a:off x="2660400" y="3492360"/>
            <a:ext cx="332640" cy="10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CI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52"/>
          <p:cNvSpPr/>
          <p:nvPr/>
        </p:nvSpPr>
        <p:spPr>
          <a:xfrm rot="10800000">
            <a:off x="2895120" y="3492360"/>
            <a:ext cx="332640" cy="106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lag-HA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Line 118"/>
          <p:cNvSpPr/>
          <p:nvPr/>
        </p:nvSpPr>
        <p:spPr>
          <a:xfrm>
            <a:off x="2463840" y="3090960"/>
            <a:ext cx="1440" cy="168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119"/>
          <p:cNvSpPr/>
          <p:nvPr/>
        </p:nvSpPr>
        <p:spPr>
          <a:xfrm>
            <a:off x="2894040" y="3090960"/>
            <a:ext cx="0" cy="169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Line 120"/>
          <p:cNvSpPr/>
          <p:nvPr/>
        </p:nvSpPr>
        <p:spPr>
          <a:xfrm>
            <a:off x="3535200" y="3087720"/>
            <a:ext cx="0" cy="174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121"/>
          <p:cNvSpPr/>
          <p:nvPr/>
        </p:nvSpPr>
        <p:spPr>
          <a:xfrm>
            <a:off x="3963960" y="3084480"/>
            <a:ext cx="0" cy="1746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122"/>
          <p:cNvSpPr/>
          <p:nvPr/>
        </p:nvSpPr>
        <p:spPr>
          <a:xfrm>
            <a:off x="692280" y="6156360"/>
            <a:ext cx="5545080" cy="164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. S1. SRC-3 interacts with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KK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through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ts  S/T and HAT domains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A) Co-IP analysis of the interaction between SRC-3 protein and IKK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protein in 293 T cells. Cells were transfected with Flag-SRC-3 and IKK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expression plasmids and then lysed for Co-IP assays using control IgG and Flag antibody. Precipitated proteins were subjected to immunoblotting to detect Flag-SRC-3 and IKK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. (B) SRC-3 interacted with IKK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rough its S/T and HAT domains. Schematic of the functional domains of SRC-3 (upper panel) and the interaction of SRC-3 with IKK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hrough its S/T and HAT domains (lower panel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2-24T15:13:10Z</dcterms:created>
  <dc:creator>xxc</dc:creator>
  <dc:description/>
  <dc:language>en-US</dc:language>
  <cp:lastModifiedBy>xxc</cp:lastModifiedBy>
  <dcterms:modified xsi:type="dcterms:W3CDTF">2014-02-27T03:13:57Z</dcterms:modified>
  <cp:revision>26</cp:revision>
  <dc:subject/>
  <dc:title>幻灯片 1</dc:title>
</cp:coreProperties>
</file>